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2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583" autoAdjust="0"/>
    <p:restoredTop sz="88400" autoAdjust="0"/>
  </p:normalViewPr>
  <p:slideViewPr>
    <p:cSldViewPr snapToGrid="0" snapToObjects="1">
      <p:cViewPr varScale="1">
        <p:scale>
          <a:sx n="101" d="100"/>
          <a:sy n="101" d="100"/>
        </p:scale>
        <p:origin x="156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a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254102-9EEE-8047-9BDC-3665EA0D766B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a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a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20DCF8-AA3D-5B4E-9891-922D9CBAFC12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5397761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2.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oncentration-response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urves to sodium nitroprusside (SNP) in male OF-1 mice common carotid arteries incubated in the absence (Control) or presence (10%) of high-grade stenosis (HGS) stroke serum. Results are mean ± SEM of 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= 7 per group.</a:t>
            </a:r>
            <a:endParaRPr lang="es-E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D20DCF8-AA3D-5B4E-9891-922D9CBAFC12}" type="slidenum">
              <a:rPr lang="ca-ES" smtClean="0"/>
              <a:t>1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284291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0113192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629737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7670042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6176337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924844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4157774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6403731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692338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619346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9955686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0561651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475914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>
            <a:extLst>
              <a:ext uri="{FF2B5EF4-FFF2-40B4-BE49-F238E27FC236}">
                <a16:creationId xmlns:a16="http://schemas.microsoft.com/office/drawing/2014/main" id="{C80FC328-8F85-6940-9015-EEC795342A8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27350" y="2700917"/>
            <a:ext cx="4051300" cy="2751566"/>
          </a:xfrm>
          <a:prstGeom prst="rect">
            <a:avLst/>
          </a:prstGeom>
        </p:spPr>
      </p:pic>
      <p:sp>
        <p:nvSpPr>
          <p:cNvPr id="6" name="QuadreDeText 5">
            <a:extLst>
              <a:ext uri="{FF2B5EF4-FFF2-40B4-BE49-F238E27FC236}">
                <a16:creationId xmlns:a16="http://schemas.microsoft.com/office/drawing/2014/main" id="{0F85EA29-486B-F779-E8F4-CF1134D3F653}"/>
              </a:ext>
            </a:extLst>
          </p:cNvPr>
          <p:cNvSpPr txBox="1"/>
          <p:nvPr/>
        </p:nvSpPr>
        <p:spPr>
          <a:xfrm>
            <a:off x="571500" y="5718513"/>
            <a:ext cx="8763000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Supplementary Figure 2. 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Concentration-response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 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curves to sodium nitroprusside in male OF-1 mice common carotid arteries incubated in the absence (Control) or presence (10%) of high-grade stenosis (HGS) stroke serum. Results are mean ± SEM of </a:t>
            </a:r>
            <a:r>
              <a:rPr kumimoji="0" lang="en-US" sz="14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n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 = 7 per group.</a:t>
            </a:r>
            <a:endParaRPr kumimoji="0" lang="es-E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Times New Roman" panose="02020603050405020304" pitchFamily="18" charset="0"/>
              <a:cs typeface="+mn-cs"/>
            </a:endParaRPr>
          </a:p>
        </p:txBody>
      </p:sp>
      <p:sp>
        <p:nvSpPr>
          <p:cNvPr id="8" name="QuadreDeText 7">
            <a:extLst>
              <a:ext uri="{FF2B5EF4-FFF2-40B4-BE49-F238E27FC236}">
                <a16:creationId xmlns:a16="http://schemas.microsoft.com/office/drawing/2014/main" id="{B7AFDDE4-7C9B-CCC0-A53D-F4F1C191CD19}"/>
              </a:ext>
            </a:extLst>
          </p:cNvPr>
          <p:cNvSpPr txBox="1"/>
          <p:nvPr/>
        </p:nvSpPr>
        <p:spPr>
          <a:xfrm>
            <a:off x="245268" y="60966"/>
            <a:ext cx="9415464" cy="19389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rticle title: </a:t>
            </a:r>
            <a:r>
              <a:rPr lang="en-US" sz="12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rum from stroke patients with high grade carotid stenosis promotes cyclooxygenase-dependent endothelial dysfunction in non-ischemic mice carotid arteries</a:t>
            </a:r>
          </a:p>
          <a:p>
            <a:endParaRPr lang="en-US" sz="1200" i="0" dirty="0">
              <a:solidFill>
                <a:srgbClr val="333333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Journal name: </a:t>
            </a:r>
            <a:r>
              <a:rPr lang="en-US" sz="120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ranslational Stroke Research</a:t>
            </a:r>
          </a:p>
          <a:p>
            <a:endParaRPr lang="en-US" sz="1200" i="0" dirty="0">
              <a:solidFill>
                <a:srgbClr val="333333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uthor names: </a:t>
            </a:r>
            <a:r>
              <a:rPr lang="en-US" sz="120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ídia</a:t>
            </a:r>
            <a:r>
              <a:rPr lang="en-US" sz="120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uertas-Umbert</a:t>
            </a:r>
            <a:r>
              <a:rPr lang="en-US" sz="120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úria</a:t>
            </a:r>
            <a:r>
              <a:rPr lang="en-US" sz="120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Puig, Mercedes Camacho, Ana Paula </a:t>
            </a:r>
            <a:r>
              <a:rPr lang="en-US" sz="120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antas</a:t>
            </a:r>
            <a:r>
              <a:rPr lang="en-US" sz="120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Rebeca Marín, Joan Martí-</a:t>
            </a:r>
            <a:r>
              <a:rPr lang="en-US" sz="120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àbregas</a:t>
            </a:r>
            <a:r>
              <a:rPr lang="en-US" sz="120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Elena Jiménez-</a:t>
            </a:r>
            <a:r>
              <a:rPr lang="en-US" sz="120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Xarrié</a:t>
            </a:r>
            <a:r>
              <a:rPr lang="en-US" sz="120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Sonia Benítez, Pol Camps-</a:t>
            </a:r>
            <a:r>
              <a:rPr lang="en-US" sz="120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nom</a:t>
            </a:r>
            <a:r>
              <a:rPr lang="en-US" sz="120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Francesc Jiménez-</a:t>
            </a:r>
            <a:r>
              <a:rPr lang="en-US" sz="120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ltayó</a:t>
            </a:r>
            <a:endParaRPr lang="en-US" sz="1200" i="0" dirty="0">
              <a:solidFill>
                <a:srgbClr val="333333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i="0" dirty="0">
              <a:solidFill>
                <a:srgbClr val="333333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filiation and e-mail address of the corresponding author: </a:t>
            </a:r>
            <a:r>
              <a:rPr lang="en-US" sz="120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epartment of Pharmacology, Therapeutics and Toxicology, School of Medicine, </a:t>
            </a:r>
            <a:r>
              <a:rPr lang="en-US" sz="120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niversitat</a:t>
            </a:r>
            <a:r>
              <a:rPr lang="en-US" sz="120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utònoma</a:t>
            </a:r>
            <a:r>
              <a:rPr lang="en-US" sz="120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de Barcelona, Barcelona, Spain; francesc.jimenez@uab.cat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215440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74</TotalTime>
  <Words>199</Words>
  <Application>Microsoft Office PowerPoint</Application>
  <PresentationFormat>Paper A4 (210 x 297 mm)</PresentationFormat>
  <Paragraphs>10</Paragraphs>
  <Slides>1</Slides>
  <Notes>1</Notes>
  <HiddenSlides>0</HiddenSlides>
  <MMClips>0</MMClips>
  <ScaleCrop>false</ScaleCrop>
  <HeadingPairs>
    <vt:vector size="6" baseType="variant">
      <vt:variant>
        <vt:lpstr>Tipus de lletra utilitzats</vt:lpstr>
      </vt:variant>
      <vt:variant>
        <vt:i4>4</vt:i4>
      </vt:variant>
      <vt:variant>
        <vt:lpstr>Tema</vt:lpstr>
      </vt:variant>
      <vt:variant>
        <vt:i4>1</vt:i4>
      </vt:variant>
      <vt:variant>
        <vt:lpstr>Títols de l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 del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ídia Puertas Umbert</dc:creator>
  <cp:lastModifiedBy>Francesc Jimenez Altayo</cp:lastModifiedBy>
  <cp:revision>121</cp:revision>
  <dcterms:created xsi:type="dcterms:W3CDTF">2020-04-08T11:10:44Z</dcterms:created>
  <dcterms:modified xsi:type="dcterms:W3CDTF">2022-06-28T08:27:58Z</dcterms:modified>
</cp:coreProperties>
</file>